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05" r:id="rId2"/>
    <p:sldId id="318" r:id="rId3"/>
    <p:sldId id="316" r:id="rId4"/>
    <p:sldId id="319" r:id="rId5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bart Wendy" initials="DW" lastIdx="2" clrIdx="0">
    <p:extLst>
      <p:ext uri="{19B8F6BF-5375-455C-9EA6-DF929625EA0E}">
        <p15:presenceInfo xmlns:p15="http://schemas.microsoft.com/office/powerpoint/2012/main" userId="S-1-5-21-671684527-166200450-1136263860-1632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7E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642" autoAdjust="0"/>
    <p:restoredTop sz="93880" autoAdjust="0"/>
  </p:normalViewPr>
  <p:slideViewPr>
    <p:cSldViewPr snapToGrid="0">
      <p:cViewPr varScale="1">
        <p:scale>
          <a:sx n="109" d="100"/>
          <a:sy n="109" d="100"/>
        </p:scale>
        <p:origin x="576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D4CB59-B4CC-4DB0-8198-E31BB3845009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BE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D3C378-2718-4FCB-8D31-A5017692ED0D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003792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167834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998517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341374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80102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243145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62606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70460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649210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555931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921645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4148380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12BAD-9588-44BA-AE4E-0AAEC9C968A8}" type="datetimeFigureOut">
              <a:rPr lang="fr-BE" smtClean="0"/>
              <a:t>3/10/2022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B4B9E-53F9-4AD4-A53F-FF5AF5171E43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285058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6612355"/>
              </p:ext>
            </p:extLst>
          </p:nvPr>
        </p:nvGraphicFramePr>
        <p:xfrm>
          <a:off x="493349" y="406078"/>
          <a:ext cx="6522914" cy="539698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7872"/>
                <a:gridCol w="1165771"/>
                <a:gridCol w="1254920"/>
                <a:gridCol w="1549483"/>
                <a:gridCol w="1284868"/>
              </a:tblGrid>
              <a:tr h="440353">
                <a:tc>
                  <a:txBody>
                    <a:bodyPr/>
                    <a:lstStyle/>
                    <a:p>
                      <a:pPr algn="ctr"/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baseline="300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RT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L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6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0.8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3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0.6</a:t>
                      </a:r>
                      <a:endParaRPr lang="fr-B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0.8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6</a:t>
                      </a:r>
                      <a:endParaRPr lang="fr-BE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162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4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2.3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6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-677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2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0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0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5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1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8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JM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3 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5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0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7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4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7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3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3.6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5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A-PACA-2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5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.1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7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1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4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± 1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1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5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4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4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6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rowSpan="3">
                  <a:txBody>
                    <a:bodyPr/>
                    <a:lstStyle/>
                    <a:p>
                      <a:pPr algn="ctr"/>
                      <a:endParaRPr lang="fr-BE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-29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.2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5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4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8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485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fr-BE" sz="1200" b="1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6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.2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3192">
                <a:tc vMerge="1">
                  <a:txBody>
                    <a:bodyPr/>
                    <a:lstStyle/>
                    <a:p>
                      <a:pPr algn="ctr"/>
                      <a:endParaRPr lang="fr-BE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 (%)</a:t>
                      </a:r>
                      <a:endParaRPr lang="fr-BE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9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9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7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9 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BE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2 </a:t>
                      </a:r>
                      <a:r>
                        <a:rPr lang="fr-BE" sz="12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3</a:t>
                      </a:r>
                      <a:endParaRPr lang="fr-BE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ZoneTexte 6"/>
          <p:cNvSpPr txBox="1"/>
          <p:nvPr/>
        </p:nvSpPr>
        <p:spPr>
          <a:xfrm>
            <a:off x="450368" y="5882028"/>
            <a:ext cx="65658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BE" sz="105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-DOTATATE and EBRT on the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ycle distribution in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lanoma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HBL and MM162), multiple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yeloma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COLO-677 and EJM) </a:t>
            </a:r>
            <a:r>
              <a:rPr lang="fr-BE" sz="1050" b="1" dirty="0">
                <a:latin typeface="Arial" panose="020B0604020202020204" pitchFamily="34" charset="0"/>
                <a:cs typeface="Arial" panose="020B0604020202020204" pitchFamily="34" charset="0"/>
              </a:rPr>
              <a:t>and GEP (MIA-PACA-2 and HT-29)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cycle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assessed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4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incubation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5 </a:t>
            </a:r>
            <a:r>
              <a:rPr lang="fr-BE" sz="1050" dirty="0" err="1">
                <a:latin typeface="Arial" panose="020B0604020202020204" pitchFamily="34" charset="0"/>
                <a:cs typeface="Arial" panose="020B0604020202020204" pitchFamily="34" charset="0"/>
              </a:rPr>
              <a:t>MBq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BE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Lu-DOTATATE or 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2 Gy 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EBRT.</a:t>
            </a:r>
            <a:r>
              <a:rPr lang="fr-BE" sz="1050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ed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± SEM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n = 3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3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pendant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3945455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205019"/>
              </p:ext>
            </p:extLst>
          </p:nvPr>
        </p:nvGraphicFramePr>
        <p:xfrm>
          <a:off x="710505" y="415725"/>
          <a:ext cx="7451982" cy="30237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41723"/>
                <a:gridCol w="1241723"/>
                <a:gridCol w="1241723"/>
                <a:gridCol w="1241723"/>
                <a:gridCol w="1242545"/>
                <a:gridCol w="1242545"/>
              </a:tblGrid>
              <a:tr h="103376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aparib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1400" baseline="300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100" baseline="300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7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-DOTATATE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aparib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14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RT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endParaRPr lang="en-US" sz="7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RT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</a:t>
                      </a:r>
                      <a:r>
                        <a:rPr lang="en-US" sz="14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aparib</a:t>
                      </a:r>
                      <a:endParaRPr lang="fr-BE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37091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BE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BL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.4 ± 2.5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.3 ± 2.6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.3 ± 3.5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1 ± 2.1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.5 ± 1.3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3556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BE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162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5 ± 3.5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3 ± 3.3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6 ± 3.0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1 ± 2.2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2 ± 2.6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2717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BE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O-677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9 ± 0.8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7 ± 2.4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3 ± 1.7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.5 ± 1.2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3 ± 1.4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3556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BE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JM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 ± 1.9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.6 ± 2.0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1 ± 2.5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.5 ± </a:t>
                      </a:r>
                      <a:r>
                        <a:rPr lang="fr-BE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.3 ± 3.0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4394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fr-BE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A-PACA-2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.7 ± 4.0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.8 ± 2.4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 ± 3.0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4 ± 4.7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.0 ± 1.4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683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T-29</a:t>
                      </a:r>
                      <a:endParaRPr lang="fr-BE" sz="1400" b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.4 ± 3.7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6 ± 3.6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.2 ± 3.4</a:t>
                      </a:r>
                      <a:endParaRPr lang="fr-BE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2 ± 2.4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.2 ± 4.4</a:t>
                      </a:r>
                      <a:endParaRPr lang="fr-BE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710505" y="3581671"/>
            <a:ext cx="7544262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ffect of </a:t>
            </a:r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olaparib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and its combination with </a:t>
            </a:r>
            <a:r>
              <a:rPr lang="en-US" sz="105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Lu-DOTATATE and EBRT on survival of melanoma (HBL and MM162), multiple myeloma (COLO-677 and EJM) and GEP (MIA-PACA-2 and HT-29) cell lines.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Cell survival was assessed 10 days after 4 hours incubation with 5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MBq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Lu-DOTATATE or 2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EBRT.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Olaparib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(HBL, MM162 and HT-29: 10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6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; MIA-PACA-2 and EJM: 10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7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; COLO-677: 10</a:t>
            </a:r>
            <a:r>
              <a:rPr lang="en-US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) was present in the medium from the day before irradiation until the end of the experiment. Results are expressed as a percentage of the non-treated counterpart and are represented as mean ± SEM (n = 12 from 3 </a:t>
            </a:r>
            <a:r>
              <a:rPr lang="en-US" sz="1050" dirty="0" err="1">
                <a:latin typeface="Arial" panose="020B0604020202020204" pitchFamily="34" charset="0"/>
                <a:cs typeface="Arial" panose="020B0604020202020204" pitchFamily="34" charset="0"/>
              </a:rPr>
              <a:t>independant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experiments). </a:t>
            </a:r>
            <a:endParaRPr lang="fr-B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8278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2823410" y="5480726"/>
            <a:ext cx="559285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PARP1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 expression in </a:t>
            </a:r>
            <a:r>
              <a:rPr lang="fr-BE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elanoma</a:t>
            </a:r>
            <a:r>
              <a:rPr lang="fr-BE" sz="1050" b="1" dirty="0">
                <a:latin typeface="Arial" panose="020B0604020202020204" pitchFamily="34" charset="0"/>
                <a:cs typeface="Arial" panose="020B0604020202020204" pitchFamily="34" charset="0"/>
              </a:rPr>
              <a:t> (HBL and MM162), multiple myeloma (COLO-677 and EJM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BE" sz="1050" b="1" dirty="0">
                <a:latin typeface="Arial" panose="020B0604020202020204" pitchFamily="34" charset="0"/>
                <a:cs typeface="Arial" panose="020B0604020202020204" pitchFamily="34" charset="0"/>
              </a:rPr>
              <a:t>and GEP (MIA-PACA-2 and HT-29) </a:t>
            </a:r>
            <a:r>
              <a:rPr lang="fr-BE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050" b="1" dirty="0">
                <a:latin typeface="Arial" panose="020B0604020202020204" pitchFamily="34" charset="0"/>
                <a:cs typeface="Arial" panose="020B0604020202020204" pitchFamily="34" charset="0"/>
              </a:rPr>
              <a:t> lines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50" dirty="0" smtClean="0"/>
              <a:t>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Results are represented as mean expression levels ± SEM (n =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3)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and are normalized against the reference </a:t>
            </a:r>
            <a:r>
              <a:rPr lang="en-US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gene </a:t>
            </a:r>
            <a:r>
              <a:rPr lang="en-US" sz="1050" i="1" dirty="0" smtClean="0">
                <a:latin typeface="Arial" panose="020B0604020202020204" pitchFamily="34" charset="0"/>
                <a:cs typeface="Arial" panose="020B0604020202020204" pitchFamily="34" charset="0"/>
              </a:rPr>
              <a:t>18S </a:t>
            </a:r>
            <a:r>
              <a:rPr lang="en-US" sz="10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RNA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 that was stable among cell lines.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8242" y="775730"/>
            <a:ext cx="5592858" cy="4561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72693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8">
            <a:extLst>
              <a:ext uri="{FF2B5EF4-FFF2-40B4-BE49-F238E27FC236}">
                <a16:creationId xmlns:a16="http://schemas.microsoft.com/office/drawing/2014/main" xmlns="" id="{6C2CA160-C117-404F-A04D-A91925E4BC78}"/>
              </a:ext>
            </a:extLst>
          </p:cNvPr>
          <p:cNvGrpSpPr/>
          <p:nvPr/>
        </p:nvGrpSpPr>
        <p:grpSpPr>
          <a:xfrm>
            <a:off x="105866" y="1362583"/>
            <a:ext cx="11992094" cy="3201361"/>
            <a:chOff x="4211047" y="3839000"/>
            <a:chExt cx="7374317" cy="2659269"/>
          </a:xfrm>
        </p:grpSpPr>
        <p:cxnSp>
          <p:nvCxnSpPr>
            <p:cNvPr id="5" name="Straight Arrow Connector 21">
              <a:extLst>
                <a:ext uri="{FF2B5EF4-FFF2-40B4-BE49-F238E27FC236}">
                  <a16:creationId xmlns:a16="http://schemas.microsoft.com/office/drawing/2014/main" xmlns="" id="{2B4555C0-381C-4857-8ECF-D656740CFFC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11053" y="3839000"/>
              <a:ext cx="0" cy="236929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22">
              <a:extLst>
                <a:ext uri="{FF2B5EF4-FFF2-40B4-BE49-F238E27FC236}">
                  <a16:creationId xmlns:a16="http://schemas.microsoft.com/office/drawing/2014/main" xmlns="" id="{2F89AEF3-C7F4-4B92-B2BF-B0214D6FDF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11047" y="6208295"/>
              <a:ext cx="7350875" cy="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25">
              <a:extLst>
                <a:ext uri="{FF2B5EF4-FFF2-40B4-BE49-F238E27FC236}">
                  <a16:creationId xmlns:a16="http://schemas.microsoft.com/office/drawing/2014/main" xmlns="" id="{CF7906E3-848C-447A-AD20-6AEFF56BFFA3}"/>
                </a:ext>
              </a:extLst>
            </p:cNvPr>
            <p:cNvSpPr txBox="1"/>
            <p:nvPr/>
          </p:nvSpPr>
          <p:spPr>
            <a:xfrm>
              <a:off x="11103732" y="6191477"/>
              <a:ext cx="481632" cy="3067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Time </a:t>
              </a:r>
            </a:p>
          </p:txBody>
        </p:sp>
        <p:sp>
          <p:nvSpPr>
            <p:cNvPr id="8" name="TextBox 27">
              <a:extLst>
                <a:ext uri="{FF2B5EF4-FFF2-40B4-BE49-F238E27FC236}">
                  <a16:creationId xmlns:a16="http://schemas.microsoft.com/office/drawing/2014/main" xmlns="" id="{36C17E65-4459-4108-A2A3-DCD40937D9BD}"/>
                </a:ext>
              </a:extLst>
            </p:cNvPr>
            <p:cNvSpPr txBox="1"/>
            <p:nvPr/>
          </p:nvSpPr>
          <p:spPr>
            <a:xfrm>
              <a:off x="4211053" y="3858519"/>
              <a:ext cx="665570" cy="3067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ctivity </a:t>
              </a:r>
            </a:p>
          </p:txBody>
        </p:sp>
      </p:grpSp>
      <p:grpSp>
        <p:nvGrpSpPr>
          <p:cNvPr id="9" name="Group 43">
            <a:extLst>
              <a:ext uri="{FF2B5EF4-FFF2-40B4-BE49-F238E27FC236}">
                <a16:creationId xmlns:a16="http://schemas.microsoft.com/office/drawing/2014/main" xmlns="" id="{6DA97D1C-1854-4DB9-ABE3-92EFCD3C4352}"/>
              </a:ext>
            </a:extLst>
          </p:cNvPr>
          <p:cNvGrpSpPr/>
          <p:nvPr/>
        </p:nvGrpSpPr>
        <p:grpSpPr>
          <a:xfrm>
            <a:off x="5356189" y="2115577"/>
            <a:ext cx="486030" cy="2545876"/>
            <a:chOff x="7030466" y="3934326"/>
            <a:chExt cx="486030" cy="2713496"/>
          </a:xfrm>
        </p:grpSpPr>
        <p:sp>
          <p:nvSpPr>
            <p:cNvPr id="10" name="TextBox 44">
              <a:extLst>
                <a:ext uri="{FF2B5EF4-FFF2-40B4-BE49-F238E27FC236}">
                  <a16:creationId xmlns:a16="http://schemas.microsoft.com/office/drawing/2014/main" xmlns="" id="{1D93B025-E37B-4747-AF0C-3CF27745CCFA}"/>
                </a:ext>
              </a:extLst>
            </p:cNvPr>
            <p:cNvSpPr txBox="1"/>
            <p:nvPr/>
          </p:nvSpPr>
          <p:spPr>
            <a:xfrm>
              <a:off x="7030466" y="6278490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4 h</a:t>
              </a:r>
            </a:p>
          </p:txBody>
        </p:sp>
        <p:cxnSp>
          <p:nvCxnSpPr>
            <p:cNvPr id="11" name="Straight Connector 45">
              <a:extLst>
                <a:ext uri="{FF2B5EF4-FFF2-40B4-BE49-F238E27FC236}">
                  <a16:creationId xmlns:a16="http://schemas.microsoft.com/office/drawing/2014/main" xmlns="" id="{D27BE4B7-8473-437A-B573-C06B5BF555A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267069" y="3934326"/>
              <a:ext cx="6411" cy="2250532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Freeform: Shape 13">
            <a:extLst>
              <a:ext uri="{FF2B5EF4-FFF2-40B4-BE49-F238E27FC236}">
                <a16:creationId xmlns:a16="http://schemas.microsoft.com/office/drawing/2014/main" xmlns="" id="{C557B14B-8085-4F60-BD26-F243695D48CF}"/>
              </a:ext>
            </a:extLst>
          </p:cNvPr>
          <p:cNvSpPr/>
          <p:nvPr/>
        </p:nvSpPr>
        <p:spPr>
          <a:xfrm>
            <a:off x="136300" y="2365513"/>
            <a:ext cx="5456583" cy="1033670"/>
          </a:xfrm>
          <a:custGeom>
            <a:avLst/>
            <a:gdLst>
              <a:gd name="connsiteX0" fmla="*/ 0 w 5456583"/>
              <a:gd name="connsiteY0" fmla="*/ 0 h 1033670"/>
              <a:gd name="connsiteX1" fmla="*/ 2524539 w 5456583"/>
              <a:gd name="connsiteY1" fmla="*/ 655983 h 1033670"/>
              <a:gd name="connsiteX2" fmla="*/ 5456583 w 5456583"/>
              <a:gd name="connsiteY2" fmla="*/ 1033670 h 103367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456583" h="1033670">
                <a:moveTo>
                  <a:pt x="0" y="0"/>
                </a:moveTo>
                <a:cubicBezTo>
                  <a:pt x="807554" y="241852"/>
                  <a:pt x="1615109" y="483705"/>
                  <a:pt x="2524539" y="655983"/>
                </a:cubicBezTo>
                <a:cubicBezTo>
                  <a:pt x="3433969" y="828261"/>
                  <a:pt x="4956313" y="950844"/>
                  <a:pt x="5456583" y="1033670"/>
                </a:cubicBezTo>
              </a:path>
            </a:pathLst>
          </a:cu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Freeform: Shape 23">
            <a:extLst>
              <a:ext uri="{FF2B5EF4-FFF2-40B4-BE49-F238E27FC236}">
                <a16:creationId xmlns:a16="http://schemas.microsoft.com/office/drawing/2014/main" xmlns="" id="{EB14F06C-89D9-4A33-82D6-D1DC3B5D1BC0}"/>
              </a:ext>
            </a:extLst>
          </p:cNvPr>
          <p:cNvSpPr/>
          <p:nvPr/>
        </p:nvSpPr>
        <p:spPr>
          <a:xfrm>
            <a:off x="5587822" y="3734511"/>
            <a:ext cx="5034261" cy="380289"/>
          </a:xfrm>
          <a:custGeom>
            <a:avLst/>
            <a:gdLst>
              <a:gd name="connsiteX0" fmla="*/ 0 w 4989444"/>
              <a:gd name="connsiteY0" fmla="*/ 0 h 467139"/>
              <a:gd name="connsiteX1" fmla="*/ 2117035 w 4989444"/>
              <a:gd name="connsiteY1" fmla="*/ 357809 h 467139"/>
              <a:gd name="connsiteX2" fmla="*/ 4989444 w 4989444"/>
              <a:gd name="connsiteY2" fmla="*/ 467139 h 4671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989444" h="467139">
                <a:moveTo>
                  <a:pt x="0" y="0"/>
                </a:moveTo>
                <a:cubicBezTo>
                  <a:pt x="642730" y="139976"/>
                  <a:pt x="1285461" y="279953"/>
                  <a:pt x="2117035" y="357809"/>
                </a:cubicBezTo>
                <a:cubicBezTo>
                  <a:pt x="2948609" y="435665"/>
                  <a:pt x="4547153" y="448917"/>
                  <a:pt x="4989444" y="467139"/>
                </a:cubicBezTo>
              </a:path>
            </a:pathLst>
          </a:custGeom>
          <a:noFill/>
          <a:ln w="28575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7" name="TextBox 136">
            <a:extLst>
              <a:ext uri="{FF2B5EF4-FFF2-40B4-BE49-F238E27FC236}">
                <a16:creationId xmlns:a16="http://schemas.microsoft.com/office/drawing/2014/main" xmlns="" id="{FFED6E95-E9CF-431A-979B-B3F2BA4E5276}"/>
              </a:ext>
            </a:extLst>
          </p:cNvPr>
          <p:cNvSpPr txBox="1"/>
          <p:nvPr/>
        </p:nvSpPr>
        <p:spPr>
          <a:xfrm>
            <a:off x="676772" y="3776229"/>
            <a:ext cx="34695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baseline="-25000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_4h</a:t>
            </a:r>
            <a:r>
              <a:rPr lang="en-US" sz="1600" b="1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</a:t>
            </a:r>
            <a:r>
              <a:rPr lang="en-US" sz="16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= </a:t>
            </a:r>
            <a:r>
              <a:rPr lang="fr-BE" sz="1600" b="1" dirty="0" err="1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fr-BE" sz="1600" b="1" baseline="-25000" dirty="0" err="1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_frac</a:t>
            </a:r>
            <a:r>
              <a:rPr lang="fr-BE" sz="1600" b="1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1 </a:t>
            </a:r>
            <a:r>
              <a:rPr lang="fr-BE" sz="16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– </a:t>
            </a:r>
            <a:r>
              <a:rPr lang="fr-BE" sz="1600" b="1" dirty="0" err="1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fr-BE" sz="1600" b="1" baseline="30000" dirty="0" err="1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t</a:t>
            </a:r>
            <a:r>
              <a:rPr lang="fr-BE" sz="1600" b="1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*</a:t>
            </a:r>
            <a:r>
              <a:rPr lang="en-US" sz="1600" b="1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600" b="1" baseline="30000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600" b="1" baseline="30000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US" sz="1600" b="1" baseline="30000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t</a:t>
            </a:r>
            <a:r>
              <a:rPr lang="fr-BE" sz="1600" b="1" dirty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600" b="1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39">
            <a:extLst>
              <a:ext uri="{FF2B5EF4-FFF2-40B4-BE49-F238E27FC236}">
                <a16:creationId xmlns:a16="http://schemas.microsoft.com/office/drawing/2014/main" xmlns="" id="{14B2A68E-0C49-4C37-B9E1-9858E87EC60B}"/>
              </a:ext>
            </a:extLst>
          </p:cNvPr>
          <p:cNvSpPr txBox="1"/>
          <p:nvPr/>
        </p:nvSpPr>
        <p:spPr>
          <a:xfrm>
            <a:off x="2546911" y="2743556"/>
            <a:ext cx="29642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1"/>
            <a:r>
              <a:rPr lang="en-US" sz="16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baseline="-25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d</a:t>
            </a:r>
            <a:r>
              <a:rPr lang="en-US" sz="16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) = (A</a:t>
            </a:r>
            <a:r>
              <a:rPr lang="en-US" sz="1600" b="1" baseline="-25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16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r>
              <a:rPr lang="en-US" sz="1600" b="1" baseline="-25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</a:t>
            </a:r>
            <a:r>
              <a:rPr lang="en-US" sz="16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))*e</a:t>
            </a:r>
            <a:r>
              <a:rPr lang="en-US" sz="1600" b="1" baseline="3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600" b="1" baseline="3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US" sz="1600" b="1" baseline="30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t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40">
            <a:extLst>
              <a:ext uri="{FF2B5EF4-FFF2-40B4-BE49-F238E27FC236}">
                <a16:creationId xmlns:a16="http://schemas.microsoft.com/office/drawing/2014/main" xmlns="" id="{1634F069-7B91-441E-9799-6FA283794B7E}"/>
              </a:ext>
            </a:extLst>
          </p:cNvPr>
          <p:cNvSpPr txBox="1"/>
          <p:nvPr/>
        </p:nvSpPr>
        <p:spPr>
          <a:xfrm>
            <a:off x="7416237" y="3523511"/>
            <a:ext cx="22930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baseline="-250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_10d</a:t>
            </a:r>
            <a:r>
              <a:rPr lang="en-US" sz="16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</a:t>
            </a:r>
            <a:r>
              <a:rPr lang="en-US" sz="16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= </a:t>
            </a:r>
            <a:r>
              <a:rPr lang="en-US" sz="16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b="1" baseline="-250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_frac</a:t>
            </a:r>
            <a:r>
              <a:rPr lang="en-US" sz="1600" b="1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e</a:t>
            </a:r>
            <a:r>
              <a:rPr lang="en-US" sz="1600" b="1" baseline="300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l-GR" sz="1600" b="1" baseline="30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λ</a:t>
            </a:r>
            <a:r>
              <a:rPr lang="en-US" sz="1600" b="1" baseline="30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t</a:t>
            </a:r>
          </a:p>
        </p:txBody>
      </p:sp>
      <p:sp>
        <p:nvSpPr>
          <p:cNvPr id="20" name="Freeform: Shape 9">
            <a:extLst>
              <a:ext uri="{FF2B5EF4-FFF2-40B4-BE49-F238E27FC236}">
                <a16:creationId xmlns:a16="http://schemas.microsoft.com/office/drawing/2014/main" xmlns="" id="{71926B10-21F5-43B0-9740-FB3E4E26B646}"/>
              </a:ext>
            </a:extLst>
          </p:cNvPr>
          <p:cNvSpPr/>
          <p:nvPr/>
        </p:nvSpPr>
        <p:spPr>
          <a:xfrm>
            <a:off x="126361" y="3334981"/>
            <a:ext cx="5466522" cy="859331"/>
          </a:xfrm>
          <a:custGeom>
            <a:avLst/>
            <a:gdLst>
              <a:gd name="connsiteX0" fmla="*/ 0 w 5466522"/>
              <a:gd name="connsiteY0" fmla="*/ 899928 h 899928"/>
              <a:gd name="connsiteX1" fmla="*/ 1510748 w 5466522"/>
              <a:gd name="connsiteY1" fmla="*/ 15345 h 899928"/>
              <a:gd name="connsiteX2" fmla="*/ 5466522 w 5466522"/>
              <a:gd name="connsiteY2" fmla="*/ 422850 h 8999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466522" h="899928">
                <a:moveTo>
                  <a:pt x="0" y="899928"/>
                </a:moveTo>
                <a:cubicBezTo>
                  <a:pt x="299830" y="497393"/>
                  <a:pt x="599661" y="94858"/>
                  <a:pt x="1510748" y="15345"/>
                </a:cubicBezTo>
                <a:cubicBezTo>
                  <a:pt x="2421835" y="-64168"/>
                  <a:pt x="3944178" y="179341"/>
                  <a:pt x="5466522" y="422850"/>
                </a:cubicBezTo>
              </a:path>
            </a:pathLst>
          </a:custGeom>
          <a:noFill/>
          <a:ln w="28575"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1" name="Groupe 20"/>
          <p:cNvGrpSpPr/>
          <p:nvPr/>
        </p:nvGrpSpPr>
        <p:grpSpPr>
          <a:xfrm>
            <a:off x="2526330" y="1318055"/>
            <a:ext cx="732462" cy="723701"/>
            <a:chOff x="3929019" y="1268085"/>
            <a:chExt cx="732462" cy="723701"/>
          </a:xfrm>
        </p:grpSpPr>
        <p:cxnSp>
          <p:nvCxnSpPr>
            <p:cNvPr id="22" name="Connecteur droit 21"/>
            <p:cNvCxnSpPr/>
            <p:nvPr/>
          </p:nvCxnSpPr>
          <p:spPr>
            <a:xfrm>
              <a:off x="3934315" y="1268085"/>
              <a:ext cx="0" cy="7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cteur droit 22"/>
            <p:cNvCxnSpPr/>
            <p:nvPr/>
          </p:nvCxnSpPr>
          <p:spPr>
            <a:xfrm>
              <a:off x="4661481" y="1271786"/>
              <a:ext cx="0" cy="7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cteur droit 23"/>
            <p:cNvCxnSpPr/>
            <p:nvPr/>
          </p:nvCxnSpPr>
          <p:spPr>
            <a:xfrm flipH="1" flipV="1">
              <a:off x="3929019" y="1989245"/>
              <a:ext cx="727165" cy="6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/>
            <p:cNvCxnSpPr/>
            <p:nvPr/>
          </p:nvCxnSpPr>
          <p:spPr>
            <a:xfrm flipH="1" flipV="1">
              <a:off x="3933747" y="1887728"/>
              <a:ext cx="727165" cy="6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Image 2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52122" y="1901518"/>
              <a:ext cx="69985" cy="69095"/>
            </a:xfrm>
            <a:prstGeom prst="rect">
              <a:avLst/>
            </a:prstGeom>
          </p:spPr>
        </p:pic>
        <p:pic>
          <p:nvPicPr>
            <p:cNvPr id="27" name="Image 2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245727" y="1904040"/>
              <a:ext cx="69985" cy="69095"/>
            </a:xfrm>
            <a:prstGeom prst="rect">
              <a:avLst/>
            </a:prstGeom>
          </p:spPr>
        </p:pic>
        <p:pic>
          <p:nvPicPr>
            <p:cNvPr id="28" name="Image 2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39182" y="1903687"/>
              <a:ext cx="69985" cy="69095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57151" y="1623088"/>
              <a:ext cx="69985" cy="69095"/>
            </a:xfrm>
            <a:prstGeom prst="rect">
              <a:avLst/>
            </a:prstGeom>
          </p:spPr>
        </p:pic>
        <p:pic>
          <p:nvPicPr>
            <p:cNvPr id="30" name="Image 2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4457" y="1577646"/>
              <a:ext cx="69985" cy="69095"/>
            </a:xfrm>
            <a:prstGeom prst="rect">
              <a:avLst/>
            </a:prstGeom>
          </p:spPr>
        </p:pic>
        <p:pic>
          <p:nvPicPr>
            <p:cNvPr id="31" name="Image 3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09551" y="1775488"/>
              <a:ext cx="69985" cy="69095"/>
            </a:xfrm>
            <a:prstGeom prst="rect">
              <a:avLst/>
            </a:prstGeom>
          </p:spPr>
        </p:pic>
        <p:pic>
          <p:nvPicPr>
            <p:cNvPr id="32" name="Image 3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59714" y="1440499"/>
              <a:ext cx="69985" cy="69095"/>
            </a:xfrm>
            <a:prstGeom prst="rect">
              <a:avLst/>
            </a:prstGeom>
          </p:spPr>
        </p:pic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4456" y="1410336"/>
              <a:ext cx="69985" cy="69095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87742" y="1621480"/>
              <a:ext cx="69985" cy="69095"/>
            </a:xfrm>
            <a:prstGeom prst="rect">
              <a:avLst/>
            </a:prstGeom>
          </p:spPr>
        </p:pic>
        <p:pic>
          <p:nvPicPr>
            <p:cNvPr id="35" name="Image 3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38070" y="1491358"/>
              <a:ext cx="69985" cy="69095"/>
            </a:xfrm>
            <a:prstGeom prst="rect">
              <a:avLst/>
            </a:prstGeom>
          </p:spPr>
        </p:pic>
        <p:pic>
          <p:nvPicPr>
            <p:cNvPr id="36" name="Image 3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76251" y="1457930"/>
              <a:ext cx="69985" cy="69095"/>
            </a:xfrm>
            <a:prstGeom prst="rect">
              <a:avLst/>
            </a:prstGeom>
          </p:spPr>
        </p:pic>
        <p:pic>
          <p:nvPicPr>
            <p:cNvPr id="37" name="Image 3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39866" y="1735834"/>
              <a:ext cx="69985" cy="69095"/>
            </a:xfrm>
            <a:prstGeom prst="rect">
              <a:avLst/>
            </a:prstGeom>
          </p:spPr>
        </p:pic>
      </p:grpSp>
      <p:grpSp>
        <p:nvGrpSpPr>
          <p:cNvPr id="38" name="Groupe 37"/>
          <p:cNvGrpSpPr/>
          <p:nvPr/>
        </p:nvGrpSpPr>
        <p:grpSpPr>
          <a:xfrm>
            <a:off x="8100199" y="1318803"/>
            <a:ext cx="732462" cy="723701"/>
            <a:chOff x="3929019" y="1268085"/>
            <a:chExt cx="732462" cy="723701"/>
          </a:xfrm>
        </p:grpSpPr>
        <p:cxnSp>
          <p:nvCxnSpPr>
            <p:cNvPr id="39" name="Connecteur droit 38"/>
            <p:cNvCxnSpPr/>
            <p:nvPr/>
          </p:nvCxnSpPr>
          <p:spPr>
            <a:xfrm>
              <a:off x="3934315" y="1268085"/>
              <a:ext cx="0" cy="7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Connecteur droit 39"/>
            <p:cNvCxnSpPr/>
            <p:nvPr/>
          </p:nvCxnSpPr>
          <p:spPr>
            <a:xfrm>
              <a:off x="4661481" y="1271786"/>
              <a:ext cx="0" cy="720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Connecteur droit 40"/>
            <p:cNvCxnSpPr/>
            <p:nvPr/>
          </p:nvCxnSpPr>
          <p:spPr>
            <a:xfrm flipH="1" flipV="1">
              <a:off x="3929019" y="1989245"/>
              <a:ext cx="727165" cy="6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cteur droit 41"/>
            <p:cNvCxnSpPr/>
            <p:nvPr/>
          </p:nvCxnSpPr>
          <p:spPr>
            <a:xfrm flipH="1" flipV="1">
              <a:off x="3933747" y="1887728"/>
              <a:ext cx="727165" cy="65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3" name="Image 4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09272" y="1901518"/>
              <a:ext cx="69985" cy="69095"/>
            </a:xfrm>
            <a:prstGeom prst="rect">
              <a:avLst/>
            </a:prstGeom>
          </p:spPr>
        </p:pic>
        <p:pic>
          <p:nvPicPr>
            <p:cNvPr id="44" name="Image 4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91557" y="1903687"/>
              <a:ext cx="69985" cy="69095"/>
            </a:xfrm>
            <a:prstGeom prst="rect">
              <a:avLst/>
            </a:prstGeom>
          </p:spPr>
        </p:pic>
      </p:grpSp>
      <p:sp>
        <p:nvSpPr>
          <p:cNvPr id="45" name="ZoneTexte 44"/>
          <p:cNvSpPr txBox="1"/>
          <p:nvPr/>
        </p:nvSpPr>
        <p:spPr>
          <a:xfrm>
            <a:off x="3494471" y="1816934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3500807" y="146869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fr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Connecteur droit 46"/>
          <p:cNvCxnSpPr/>
          <p:nvPr/>
        </p:nvCxnSpPr>
        <p:spPr>
          <a:xfrm flipH="1" flipV="1">
            <a:off x="2521533" y="1423348"/>
            <a:ext cx="727165" cy="65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cteur droit 47"/>
          <p:cNvCxnSpPr/>
          <p:nvPr/>
        </p:nvCxnSpPr>
        <p:spPr>
          <a:xfrm flipH="1" flipV="1">
            <a:off x="8103183" y="1423348"/>
            <a:ext cx="727165" cy="65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droit avec flèche 48"/>
          <p:cNvCxnSpPr/>
          <p:nvPr/>
        </p:nvCxnSpPr>
        <p:spPr>
          <a:xfrm>
            <a:off x="3180281" y="1618359"/>
            <a:ext cx="324000" cy="11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cteur droit avec flèche 49"/>
          <p:cNvCxnSpPr/>
          <p:nvPr/>
        </p:nvCxnSpPr>
        <p:spPr>
          <a:xfrm>
            <a:off x="3180433" y="1990833"/>
            <a:ext cx="324000" cy="11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/>
          <p:nvPr/>
        </p:nvSpPr>
        <p:spPr>
          <a:xfrm>
            <a:off x="9038021" y="1816934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9044357" y="1468691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edium</a:t>
            </a:r>
            <a:endParaRPr lang="fr-B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Connecteur droit avec flèche 52"/>
          <p:cNvCxnSpPr/>
          <p:nvPr/>
        </p:nvCxnSpPr>
        <p:spPr>
          <a:xfrm>
            <a:off x="8723831" y="1618359"/>
            <a:ext cx="324000" cy="11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cteur droit avec flèche 53"/>
          <p:cNvCxnSpPr/>
          <p:nvPr/>
        </p:nvCxnSpPr>
        <p:spPr>
          <a:xfrm>
            <a:off x="8723983" y="1990833"/>
            <a:ext cx="324000" cy="119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1302192" y="3470708"/>
            <a:ext cx="19175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u="sng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 in the cells</a:t>
            </a:r>
            <a:r>
              <a:rPr lang="fr-BE" sz="1600" dirty="0" smtClean="0">
                <a:solidFill>
                  <a:schemeClr val="accent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BE" sz="1600" dirty="0">
              <a:solidFill>
                <a:schemeClr val="accent5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2936900" y="2430232"/>
            <a:ext cx="22381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u="sng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 in the medium</a:t>
            </a:r>
            <a:r>
              <a:rPr lang="fr-BE" sz="16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BE" sz="16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7537373" y="3221546"/>
            <a:ext cx="19175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600" u="sng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ty in the cells</a:t>
            </a:r>
            <a:r>
              <a:rPr lang="fr-BE" sz="1600" dirty="0" smtClean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BE" sz="16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396522" y="4816133"/>
            <a:ext cx="1133255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chematic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ation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erimental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u-DOTATATE,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the Monte Carlo simulations,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resenting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artments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medium and cells) 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s a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time (Time Activity </a:t>
            </a:r>
            <a:r>
              <a:rPr lang="fr-BE" sz="10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fr-BE" sz="1050" b="1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the 4h incubation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177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Lu-DOTATATE,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sent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in the medium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nalizing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in the cells.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the 4h incubation, radioactive medium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placed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by a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esh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medium and cells are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ept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for 10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ich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ernalized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BE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0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caying</a:t>
            </a:r>
            <a:r>
              <a:rPr lang="fr-BE" sz="105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fr-BE" sz="10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fr-BE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5158015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6" grpId="0" animBg="1"/>
      <p:bldP spid="17" grpId="0"/>
      <p:bldP spid="18" grpId="0"/>
      <p:bldP spid="19" grpId="0"/>
    </p:bld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442</TotalTime>
  <Words>685</Words>
  <Application>Microsoft Office PowerPoint</Application>
  <PresentationFormat>Grand écran</PresentationFormat>
  <Paragraphs>151</Paragraphs>
  <Slides>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elbart Wendy</dc:creator>
  <cp:lastModifiedBy>Delbart Wendy</cp:lastModifiedBy>
  <cp:revision>801</cp:revision>
  <dcterms:created xsi:type="dcterms:W3CDTF">2020-04-06T13:23:03Z</dcterms:created>
  <dcterms:modified xsi:type="dcterms:W3CDTF">2022-10-03T12:16:56Z</dcterms:modified>
</cp:coreProperties>
</file>